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44" r:id="rId1"/>
  </p:sldMasterIdLst>
  <p:notesMasterIdLst>
    <p:notesMasterId r:id="rId3"/>
  </p:notesMasterIdLst>
  <p:sldIdLst>
    <p:sldId id="259" r:id="rId2"/>
  </p:sldIdLst>
  <p:sldSz cx="14400213" cy="11160125"/>
  <p:notesSz cx="6858000" cy="9144000"/>
  <p:defaultTextStyle>
    <a:defPPr>
      <a:defRPr lang="ja-JP"/>
    </a:defPPr>
    <a:lvl1pPr marL="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1pPr>
    <a:lvl2pPr marL="691195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2pPr>
    <a:lvl3pPr marL="138239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3pPr>
    <a:lvl4pPr marL="2073585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4pPr>
    <a:lvl5pPr marL="276478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5pPr>
    <a:lvl6pPr marL="3455975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6pPr>
    <a:lvl7pPr marL="414717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7pPr>
    <a:lvl8pPr marL="4838365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8pPr>
    <a:lvl9pPr marL="5529560" algn="l" defTabSz="1382390" rtl="0" eaLnBrk="1" latinLnBrk="0" hangingPunct="1">
      <a:defRPr kumimoji="1" sz="272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15" userDrawn="1">
          <p15:clr>
            <a:srgbClr val="A4A3A4"/>
          </p15:clr>
        </p15:guide>
        <p15:guide id="2" pos="45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38"/>
    <p:restoredTop sz="94702"/>
  </p:normalViewPr>
  <p:slideViewPr>
    <p:cSldViewPr snapToGrid="0" snapToObjects="1" showGuides="1">
      <p:cViewPr varScale="1">
        <p:scale>
          <a:sx n="126" d="100"/>
          <a:sy n="126" d="100"/>
        </p:scale>
        <p:origin x="1024" y="208"/>
      </p:cViewPr>
      <p:guideLst>
        <p:guide orient="horz" pos="3515"/>
        <p:guide pos="45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1A7B3D-5763-594E-96FA-A8EC9EDC1D8F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438275" y="1143000"/>
            <a:ext cx="3981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C8CEE-CECF-0D42-8003-07ED1C4B41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3754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7" y="1826440"/>
            <a:ext cx="12240181" cy="388537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5861650"/>
            <a:ext cx="10800160" cy="2694446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812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525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594173"/>
            <a:ext cx="3105046" cy="945769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6" y="594173"/>
            <a:ext cx="9135135" cy="945769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674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6828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2782287"/>
            <a:ext cx="12420184" cy="464230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7468505"/>
            <a:ext cx="12420184" cy="2441277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40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5" y="2970869"/>
            <a:ext cx="6120091" cy="708099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2970869"/>
            <a:ext cx="6120091" cy="708099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256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594176"/>
            <a:ext cx="12420184" cy="215710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2735782"/>
            <a:ext cx="6091964" cy="1340764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4076547"/>
            <a:ext cx="6091964" cy="59959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2735782"/>
            <a:ext cx="6121966" cy="1340764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4076547"/>
            <a:ext cx="6121966" cy="59959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664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8368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848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44010"/>
            <a:ext cx="4644444" cy="2604029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1606854"/>
            <a:ext cx="7290108" cy="793092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348037"/>
            <a:ext cx="4644444" cy="6202654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370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44010"/>
            <a:ext cx="4644444" cy="2604029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1606854"/>
            <a:ext cx="7290108" cy="793092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348037"/>
            <a:ext cx="4644444" cy="6202654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43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594176"/>
            <a:ext cx="12420184" cy="2157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2970869"/>
            <a:ext cx="12420184" cy="70809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0343787"/>
            <a:ext cx="3240048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200D3-893C-6C40-A2D8-B52CEA1F7ED4}" type="datetimeFigureOut">
              <a:rPr kumimoji="1" lang="ja-JP" altLang="en-US" smtClean="0"/>
              <a:t>2020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0343787"/>
            <a:ext cx="4860072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0343787"/>
            <a:ext cx="3240048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DA669-A697-D441-BF53-30FEC42A4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4692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kumimoji="1"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kumimoji="1"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CEB727C-9952-314A-8F5C-9F841C1BB936}"/>
              </a:ext>
            </a:extLst>
          </p:cNvPr>
          <p:cNvSpPr txBox="1"/>
          <p:nvPr/>
        </p:nvSpPr>
        <p:spPr>
          <a:xfrm>
            <a:off x="920969" y="8086741"/>
            <a:ext cx="125598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3200" b="1" dirty="0">
                <a:solidFill>
                  <a:srgbClr val="FF0000"/>
                </a:solidFill>
              </a:rPr>
              <a:t>Additional File 2</a:t>
            </a:r>
            <a:r>
              <a:rPr lang="en-US" altLang="ja-JP" sz="3200" b="1" dirty="0"/>
              <a:t>:</a:t>
            </a:r>
            <a:r>
              <a:rPr lang="ja-JP" altLang="ja-JP" sz="3200" dirty="0"/>
              <a:t> </a:t>
            </a:r>
            <a:r>
              <a:rPr lang="en-US" altLang="ja-JP" sz="3200" b="1" dirty="0">
                <a:solidFill>
                  <a:srgbClr val="000000"/>
                </a:solidFill>
                <a:cs typeface="Calibri" panose="020F0502020204030204" pitchFamily="34" charset="0"/>
              </a:rPr>
              <a:t>Figure </a:t>
            </a:r>
            <a:r>
              <a:rPr lang="en-US" altLang="ja-JP" sz="3200" b="1" dirty="0" err="1">
                <a:solidFill>
                  <a:srgbClr val="000000"/>
                </a:solidFill>
                <a:cs typeface="Calibri" panose="020F0502020204030204" pitchFamily="34" charset="0"/>
              </a:rPr>
              <a:t>S1</a:t>
            </a:r>
            <a:r>
              <a:rPr lang="ja-JP" altLang="ja-JP" sz="3200" b="1" dirty="0"/>
              <a:t> (Online only)</a:t>
            </a:r>
            <a:r>
              <a:rPr lang="en-US" altLang="ja-JP" sz="3200" b="1" dirty="0">
                <a:solidFill>
                  <a:srgbClr val="000000"/>
                </a:solidFill>
                <a:cs typeface="Calibri" panose="020F0502020204030204" pitchFamily="34" charset="0"/>
              </a:rPr>
              <a:t>.</a:t>
            </a:r>
            <a:endParaRPr lang="ja-JP" altLang="en-US" sz="3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126EEE83-BB42-F74A-A8B2-DE2DC99D69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0796287"/>
              </p:ext>
            </p:extLst>
          </p:nvPr>
        </p:nvGraphicFramePr>
        <p:xfrm>
          <a:off x="657609" y="1298713"/>
          <a:ext cx="13086583" cy="53002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11509">
                  <a:extLst>
                    <a:ext uri="{9D8B030D-6E8A-4147-A177-3AD203B41FA5}">
                      <a16:colId xmlns:a16="http://schemas.microsoft.com/office/drawing/2014/main" val="3632577637"/>
                    </a:ext>
                  </a:extLst>
                </a:gridCol>
                <a:gridCol w="281319">
                  <a:extLst>
                    <a:ext uri="{9D8B030D-6E8A-4147-A177-3AD203B41FA5}">
                      <a16:colId xmlns:a16="http://schemas.microsoft.com/office/drawing/2014/main" val="4200390300"/>
                    </a:ext>
                  </a:extLst>
                </a:gridCol>
                <a:gridCol w="1139556">
                  <a:extLst>
                    <a:ext uri="{9D8B030D-6E8A-4147-A177-3AD203B41FA5}">
                      <a16:colId xmlns:a16="http://schemas.microsoft.com/office/drawing/2014/main" val="2965701585"/>
                    </a:ext>
                  </a:extLst>
                </a:gridCol>
                <a:gridCol w="742252">
                  <a:extLst>
                    <a:ext uri="{9D8B030D-6E8A-4147-A177-3AD203B41FA5}">
                      <a16:colId xmlns:a16="http://schemas.microsoft.com/office/drawing/2014/main" val="743197200"/>
                    </a:ext>
                  </a:extLst>
                </a:gridCol>
                <a:gridCol w="165977">
                  <a:extLst>
                    <a:ext uri="{9D8B030D-6E8A-4147-A177-3AD203B41FA5}">
                      <a16:colId xmlns:a16="http://schemas.microsoft.com/office/drawing/2014/main" val="3063019777"/>
                    </a:ext>
                  </a:extLst>
                </a:gridCol>
                <a:gridCol w="774928">
                  <a:extLst>
                    <a:ext uri="{9D8B030D-6E8A-4147-A177-3AD203B41FA5}">
                      <a16:colId xmlns:a16="http://schemas.microsoft.com/office/drawing/2014/main" val="699183680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475064954"/>
                    </a:ext>
                  </a:extLst>
                </a:gridCol>
                <a:gridCol w="2172496">
                  <a:extLst>
                    <a:ext uri="{9D8B030D-6E8A-4147-A177-3AD203B41FA5}">
                      <a16:colId xmlns:a16="http://schemas.microsoft.com/office/drawing/2014/main" val="2866721811"/>
                    </a:ext>
                  </a:extLst>
                </a:gridCol>
                <a:gridCol w="25400">
                  <a:extLst>
                    <a:ext uri="{9D8B030D-6E8A-4147-A177-3AD203B41FA5}">
                      <a16:colId xmlns:a16="http://schemas.microsoft.com/office/drawing/2014/main" val="3959433254"/>
                    </a:ext>
                  </a:extLst>
                </a:gridCol>
                <a:gridCol w="147739">
                  <a:extLst>
                    <a:ext uri="{9D8B030D-6E8A-4147-A177-3AD203B41FA5}">
                      <a16:colId xmlns:a16="http://schemas.microsoft.com/office/drawing/2014/main" val="25896118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096722469"/>
                    </a:ext>
                  </a:extLst>
                </a:gridCol>
                <a:gridCol w="2425147">
                  <a:extLst>
                    <a:ext uri="{9D8B030D-6E8A-4147-A177-3AD203B41FA5}">
                      <a16:colId xmlns:a16="http://schemas.microsoft.com/office/drawing/2014/main" val="3384367225"/>
                    </a:ext>
                  </a:extLst>
                </a:gridCol>
                <a:gridCol w="967409">
                  <a:extLst>
                    <a:ext uri="{9D8B030D-6E8A-4147-A177-3AD203B41FA5}">
                      <a16:colId xmlns:a16="http://schemas.microsoft.com/office/drawing/2014/main" val="2935133504"/>
                    </a:ext>
                  </a:extLst>
                </a:gridCol>
                <a:gridCol w="149060">
                  <a:extLst>
                    <a:ext uri="{9D8B030D-6E8A-4147-A177-3AD203B41FA5}">
                      <a16:colId xmlns:a16="http://schemas.microsoft.com/office/drawing/2014/main" val="2881495142"/>
                    </a:ext>
                  </a:extLst>
                </a:gridCol>
                <a:gridCol w="859791">
                  <a:extLst>
                    <a:ext uri="{9D8B030D-6E8A-4147-A177-3AD203B41FA5}">
                      <a16:colId xmlns:a16="http://schemas.microsoft.com/office/drawing/2014/main" val="3719223609"/>
                    </a:ext>
                  </a:extLst>
                </a:gridCol>
              </a:tblGrid>
              <a:tr h="317443"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4">
                  <a:txBody>
                    <a:bodyPr/>
                    <a:lstStyle/>
                    <a:p>
                      <a:endParaRPr kumimoji="1" lang="ja-JP" altLang="en-US" sz="1800"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Hazard Ratio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Hazard Ratio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0411531"/>
                  </a:ext>
                </a:extLst>
              </a:tr>
              <a:tr h="317443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log[Hazard Ratio]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log[Hazard Ratio]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SE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SE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SE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Weight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IV, Random, 95% CI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IV, Random, 95% CI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800" b="1" u="none" strike="noStrike">
                          <a:effectLst/>
                          <a:latin typeface="+mn-lt"/>
                        </a:rPr>
                        <a:t>　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7900093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Nesbit 1990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703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7032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81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81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81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0.6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49 [0.35, 0.71]</a:t>
                      </a:r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3780984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Burgert 1990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4976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4976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29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29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29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8.4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61 [0.39, 0.95]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9830109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Grier(Meta) 2003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050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0502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077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077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077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9.3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95 [0.63, 1.43]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8940693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Grier(N-meta) 2003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3285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3285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17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17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17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4.4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72 [0.57, 0.91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78717228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Paulussen(SR) 2008  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089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-0.089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61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2614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61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7.2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91 [0.55, 1.53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843398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Paulussen(HR) 2008  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19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19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237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1237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237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4.0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83 [0.65, 1.05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40759554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Granowetter 2009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056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0564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021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2021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2021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9.6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1.06 [0.71, 1.57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5612579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Womer 2012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307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-0.3072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539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1539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539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2.2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74 [0.54, 0.99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112327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Le Deley 2014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133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133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173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1173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0.1173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>
                          <a:effectLst/>
                          <a:latin typeface="+mn-lt"/>
                        </a:rPr>
                        <a:t>14.40%</a:t>
                      </a:r>
                      <a:endParaRPr lang="en-US" altLang="ja-JP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1.12 [0.89, 1.41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880654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6101017"/>
                  </a:ext>
                </a:extLst>
              </a:tr>
              <a:tr h="338478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>
                          <a:effectLst/>
                          <a:latin typeface="+mn-lt"/>
                        </a:rPr>
                        <a:t>Total (95% CI)</a:t>
                      </a:r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r" fontAlgn="ctr"/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100.00%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800" b="1" u="none" strike="noStrike" dirty="0">
                          <a:effectLst/>
                          <a:latin typeface="+mn-lt"/>
                        </a:rPr>
                        <a:t>0.80 [0.68, 0.96]</a:t>
                      </a:r>
                      <a:endParaRPr lang="en-US" altLang="ja-JP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7640190"/>
                  </a:ext>
                </a:extLst>
              </a:tr>
              <a:tr h="346378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Heterogeneity: Tau² = 0.04; Chi² = 20.53, </a:t>
                      </a:r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df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 = 8 (P = 0.009); I² = 61%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3055599"/>
                  </a:ext>
                </a:extLst>
              </a:tr>
              <a:tr h="278295">
                <a:tc gridSpan="7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Test for overall effect: Z = 2.46 (P = 0.01)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1643976"/>
                  </a:ext>
                </a:extLst>
              </a:tr>
              <a:tr h="317443"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8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Favours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 [Experimental]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800" b="1" u="none" strike="noStrike" dirty="0" err="1">
                          <a:effectLst/>
                          <a:latin typeface="+mn-lt"/>
                        </a:rPr>
                        <a:t>Favours</a:t>
                      </a:r>
                      <a:r>
                        <a:rPr lang="en-US" sz="1800" b="1" u="none" strike="noStrike" dirty="0">
                          <a:effectLst/>
                          <a:latin typeface="+mn-lt"/>
                        </a:rPr>
                        <a:t> [Standard]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34" charset="-128"/>
                        <a:ea typeface="ＭＳ Ｐゴシック" panose="020B0600070205080204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750158795"/>
                  </a:ext>
                </a:extLst>
              </a:tr>
            </a:tbl>
          </a:graphicData>
        </a:graphic>
      </p:graphicFrame>
      <p:pic>
        <p:nvPicPr>
          <p:cNvPr id="9" name="図 8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PicPr>
            <a:picLocks noChangeAspect="1"/>
          </p:cNvPicPr>
          <p:nvPr/>
        </p:nvPicPr>
        <p:blipFill>
          <a:blip r:embed="rId2">
            <a:grayscl/>
          </a:blip>
          <a:stretch>
            <a:fillRect/>
          </a:stretch>
        </p:blipFill>
        <p:spPr>
          <a:xfrm>
            <a:off x="8399628" y="1959621"/>
            <a:ext cx="5504978" cy="3989819"/>
          </a:xfrm>
          <a:prstGeom prst="rect">
            <a:avLst/>
          </a:prstGeom>
        </p:spPr>
      </p:pic>
      <p:sp>
        <p:nvSpPr>
          <p:cNvPr id="12" name="テキスト ボックス 3">
            <a:extLst>
              <a:ext uri="{FF2B5EF4-FFF2-40B4-BE49-F238E27FC236}">
                <a16:creationId xmlns:a16="http://schemas.microsoft.com/office/drawing/2014/main" id="{0A7A20FF-459A-7A44-888C-3C8090EC1260}"/>
              </a:ext>
            </a:extLst>
          </p:cNvPr>
          <p:cNvSpPr txBox="1"/>
          <p:nvPr/>
        </p:nvSpPr>
        <p:spPr>
          <a:xfrm>
            <a:off x="8212037" y="5962691"/>
            <a:ext cx="6025265" cy="319080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Ins="0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800" b="1" dirty="0"/>
              <a:t>0.2                         0.5                   1                     2                           5</a:t>
            </a:r>
            <a:endParaRPr lang="ja-JP" altLang="en-US" sz="1800" b="1"/>
          </a:p>
        </p:txBody>
      </p:sp>
    </p:spTree>
    <p:extLst>
      <p:ext uri="{BB962C8B-B14F-4D97-AF65-F5344CB8AC3E}">
        <p14:creationId xmlns:p14="http://schemas.microsoft.com/office/powerpoint/2010/main" val="285604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6</TotalTime>
  <Words>235</Words>
  <Application>Microsoft Macintosh PowerPoint</Application>
  <PresentationFormat>ユーザー設定</PresentationFormat>
  <Paragraphs>6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仲和宏</dc:creator>
  <cp:lastModifiedBy>田仲和宏</cp:lastModifiedBy>
  <cp:revision>70</cp:revision>
  <cp:lastPrinted>2018-09-07T03:34:30Z</cp:lastPrinted>
  <dcterms:created xsi:type="dcterms:W3CDTF">2018-09-07T03:27:05Z</dcterms:created>
  <dcterms:modified xsi:type="dcterms:W3CDTF">2020-02-27T04:38:49Z</dcterms:modified>
</cp:coreProperties>
</file>